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26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27A2F9-D20A-4944-AAE0-FF5975E8C1F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E7061E-89D6-B03A-4288-01B0FD415C6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193FE4-4D35-286D-1076-81430F51CE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FA016-0E20-4346-9CCB-3334B0BE7075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F0F994-BAA0-4A65-5024-3A1F7B82CD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5F8450-0D9B-49B7-F178-20D18A7D91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3892C-FD73-4773-BE52-84A232B3D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220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741287-473B-4AC4-B64E-AAB117A418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772A575-F858-B090-8E74-4B8F23288E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828A0B-1368-2EF0-2F6C-E0EB38B7A0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FA016-0E20-4346-9CCB-3334B0BE7075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F23CA0-F4D9-4DE6-DF30-18E95B58F5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FAC73E-90E1-6982-4FC2-C681FB5D57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3892C-FD73-4773-BE52-84A232B3D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7732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6B8117D-B41B-E6ED-F5BB-4A317BEBE0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1B411A-08A9-6D5A-E48F-0777664681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6E3FB5-3405-C2B9-6558-A2B56CA3E0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FA016-0E20-4346-9CCB-3334B0BE7075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B5D0AD-9E35-C766-EA1C-597582919A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992DA8-9D9A-9E85-76F4-034F9DD711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3892C-FD73-4773-BE52-84A232B3D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2459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5045DB-E8E8-D941-57C1-E32DED815D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17B582-91CB-A995-A4FC-F9695E82FB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882AA3-5E5D-475F-84D1-FF82211EF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FA016-0E20-4346-9CCB-3334B0BE7075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E53A2C-D530-BB57-FA75-0F690FEC5B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9D6B45-E9E8-2606-DDB7-60E6C13C73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3892C-FD73-4773-BE52-84A232B3D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7122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B120B3-ED0A-522C-8814-E9F05F7C1D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7EEE29-F384-B944-4A06-5E53D3CCC4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E46D79-B830-6E58-8292-CFE3D8FE0F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FA016-0E20-4346-9CCB-3334B0BE7075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C25566-15A8-9579-2669-7FC67FC44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14577B-4427-6F30-C7F3-9738C0927D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3892C-FD73-4773-BE52-84A232B3D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10458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AE673B-4748-85C7-FCDB-3998771D58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755C88-3DA8-5E0C-3427-56CC8E2850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40ECF4-CC63-2DBA-D2F3-1FFD78B9F4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993A74-B9AB-CB7A-C7E7-8B3EA674A5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FA016-0E20-4346-9CCB-3334B0BE7075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8337DC-1143-4674-5908-1082B129EA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C4038D-4D37-3C42-AA71-E7AA83F5C5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3892C-FD73-4773-BE52-84A232B3D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5575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1E06CE-66D6-413F-654B-8254DA8B77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F53ADE-0DE8-A8C8-B72E-FB104EE9A6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ADEF004-777B-8112-EC23-6EA29F666D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15EECF6-E978-FA51-9FA1-91C1372FEA0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3C0D20B-DD39-23D0-C20B-96C946371FE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2BD2CE0-288C-4B66-0F63-100D89B2CF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FA016-0E20-4346-9CCB-3334B0BE7075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6ABCC83-4C33-2CD4-4B10-A2F50C5B24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CC72376-CEBD-7E80-AA2F-1FB5F7BFF3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3892C-FD73-4773-BE52-84A232B3D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5707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C42B9F-5018-9574-5E94-4487925251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9ADBD0B-D61A-D819-0ACA-2ECDACB62C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FA016-0E20-4346-9CCB-3334B0BE7075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F0F9EF4-D3E5-F4DB-22BB-083ADA78A3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9772477-7307-BE6B-F2C0-940FE1713C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3892C-FD73-4773-BE52-84A232B3D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248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1E7BD97-E251-F6CD-C54A-BE1613348B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FA016-0E20-4346-9CCB-3334B0BE7075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94EEA29-7462-D39E-5C88-4C60D763F9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0908D55-E8FF-E356-4513-7A9D38D68C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3892C-FD73-4773-BE52-84A232B3D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7138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4BA066-94A1-254B-0EDF-4B914AE468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EF37EA-ED95-39A5-56C8-0936B0EBC09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8A170B-984B-9B02-6E7F-53BC4C7FBA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B23546-F87C-7447-44FD-ECD6433262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FA016-0E20-4346-9CCB-3334B0BE7075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A7FE59-954D-F24A-0998-F94EB0E9F3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51A268-0E4D-F777-8F0B-09345E0F7B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3892C-FD73-4773-BE52-84A232B3D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6085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3A1B94-C136-FB9C-2A4A-97EEAE0D60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57CF88F-023A-3DB2-763D-62B619D5DAA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C4440F-794E-6B14-D4E0-2711471239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F24FBF-771F-AC68-F90C-6AC141500E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FA016-0E20-4346-9CCB-3334B0BE7075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70E866-B40F-23D7-9D25-7B6DEB3B19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616C5A-FB3D-383D-0B8F-76C1C35A10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3892C-FD73-4773-BE52-84A232B3D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089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AAD6C5E-A9DD-A771-3FE6-FE72DE272D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41A15F-A5D3-AB05-67FD-8A8AC74BF5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2D8B39-E604-C7B8-4A36-4C6316F0E9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1FA016-0E20-4346-9CCB-3334B0BE7075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8F99D2-A696-725D-D971-21691EC3C4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48775D-340C-51DB-1765-AF132BD959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83892C-FD73-4773-BE52-84A232B3D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486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EC55F0A0-84BB-BBEA-D458-C2254741249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983501" y="154294"/>
          <a:ext cx="3849688" cy="2974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849491" imgH="2974512" progId="Prism10.Document">
                  <p:embed/>
                </p:oleObj>
              </mc:Choice>
              <mc:Fallback>
                <p:oleObj name="Prism 10" r:id="rId2" imgW="3849491" imgH="2974512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EC55F0A0-84BB-BBEA-D458-C2254741249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983501" y="154294"/>
                        <a:ext cx="3849688" cy="2974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65A3411A-63A9-EFEE-9A88-4E685AA6FE2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604938" y="168610"/>
          <a:ext cx="3849687" cy="2974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849491" imgH="2974512" progId="Prism10.Document">
                  <p:embed/>
                </p:oleObj>
              </mc:Choice>
              <mc:Fallback>
                <p:oleObj name="Prism 10" r:id="rId4" imgW="3849491" imgH="2974512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65A3411A-63A9-EFEE-9A88-4E685AA6FE2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604938" y="168610"/>
                        <a:ext cx="3849687" cy="2974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9BE630C7-BA7D-C9CE-274C-DB786AA3BB8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978739" y="3129269"/>
          <a:ext cx="3854450" cy="2974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3854172" imgH="2974512" progId="Prism10.Document">
                  <p:embed/>
                </p:oleObj>
              </mc:Choice>
              <mc:Fallback>
                <p:oleObj name="Prism 10" r:id="rId6" imgW="3854172" imgH="2974512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9BE630C7-BA7D-C9CE-274C-DB786AA3BB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978739" y="3129269"/>
                        <a:ext cx="3854450" cy="2974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529C89EE-A18C-ED76-C97B-94310B7BBBC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716682" y="3136427"/>
          <a:ext cx="3854450" cy="2974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854172" imgH="2974512" progId="Prism10.Document">
                  <p:embed/>
                </p:oleObj>
              </mc:Choice>
              <mc:Fallback>
                <p:oleObj name="Prism 10" r:id="rId8" imgW="3854172" imgH="2974512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529C89EE-A18C-ED76-C97B-94310B7BBBC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716682" y="3136427"/>
                        <a:ext cx="3854450" cy="2974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0A3B23F6-6BD3-BD69-6F6E-01540FDC8F55}"/>
              </a:ext>
            </a:extLst>
          </p:cNvPr>
          <p:cNvGraphicFramePr>
            <a:graphicFrameLocks noGrp="1"/>
          </p:cNvGraphicFramePr>
          <p:nvPr/>
        </p:nvGraphicFramePr>
        <p:xfrm>
          <a:off x="2399514" y="2153209"/>
          <a:ext cx="941696" cy="267660"/>
        </p:xfrm>
        <a:graphic>
          <a:graphicData uri="http://schemas.openxmlformats.org/drawingml/2006/table">
            <a:tbl>
              <a:tblPr/>
              <a:tblGrid>
                <a:gridCol w="941696">
                  <a:extLst>
                    <a:ext uri="{9D8B030D-6E8A-4147-A177-3AD203B41FA5}">
                      <a16:colId xmlns:a16="http://schemas.microsoft.com/office/drawing/2014/main" val="1487705710"/>
                    </a:ext>
                  </a:extLst>
                </a:gridCol>
              </a:tblGrid>
              <a:tr h="26766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i="1" u="none" strike="noStrike" dirty="0">
                          <a:effectLst/>
                          <a:latin typeface="Arial" panose="020B0604020202020204" pitchFamily="34" charset="0"/>
                        </a:rPr>
                        <a:t>p </a:t>
                      </a:r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= 0.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8708764"/>
                  </a:ext>
                </a:extLst>
              </a:tr>
            </a:tbl>
          </a:graphicData>
        </a:graphic>
      </p:graphicFrame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20271FB9-335F-0276-26A3-30FB94C8066D}"/>
              </a:ext>
            </a:extLst>
          </p:cNvPr>
          <p:cNvGraphicFramePr>
            <a:graphicFrameLocks noGrp="1"/>
          </p:cNvGraphicFramePr>
          <p:nvPr/>
        </p:nvGraphicFramePr>
        <p:xfrm>
          <a:off x="6139281" y="2153209"/>
          <a:ext cx="941696" cy="267660"/>
        </p:xfrm>
        <a:graphic>
          <a:graphicData uri="http://schemas.openxmlformats.org/drawingml/2006/table">
            <a:tbl>
              <a:tblPr/>
              <a:tblGrid>
                <a:gridCol w="941696">
                  <a:extLst>
                    <a:ext uri="{9D8B030D-6E8A-4147-A177-3AD203B41FA5}">
                      <a16:colId xmlns:a16="http://schemas.microsoft.com/office/drawing/2014/main" val="1487705710"/>
                    </a:ext>
                  </a:extLst>
                </a:gridCol>
              </a:tblGrid>
              <a:tr h="26766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i="1" u="none" strike="noStrike" dirty="0">
                          <a:effectLst/>
                          <a:latin typeface="Arial" panose="020B0604020202020204" pitchFamily="34" charset="0"/>
                        </a:rPr>
                        <a:t>p </a:t>
                      </a:r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= 0.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8708764"/>
                  </a:ext>
                </a:extLst>
              </a:tr>
            </a:tbl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F3D6D893-EE15-48E5-2502-BFA599243C73}"/>
              </a:ext>
            </a:extLst>
          </p:cNvPr>
          <p:cNvGraphicFramePr>
            <a:graphicFrameLocks noGrp="1"/>
          </p:cNvGraphicFramePr>
          <p:nvPr/>
        </p:nvGraphicFramePr>
        <p:xfrm>
          <a:off x="2435167" y="5128184"/>
          <a:ext cx="941696" cy="267660"/>
        </p:xfrm>
        <a:graphic>
          <a:graphicData uri="http://schemas.openxmlformats.org/drawingml/2006/table">
            <a:tbl>
              <a:tblPr/>
              <a:tblGrid>
                <a:gridCol w="941696">
                  <a:extLst>
                    <a:ext uri="{9D8B030D-6E8A-4147-A177-3AD203B41FA5}">
                      <a16:colId xmlns:a16="http://schemas.microsoft.com/office/drawing/2014/main" val="1487705710"/>
                    </a:ext>
                  </a:extLst>
                </a:gridCol>
              </a:tblGrid>
              <a:tr h="26766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i="1" u="none" strike="noStrike" dirty="0">
                          <a:effectLst/>
                          <a:latin typeface="Arial" panose="020B0604020202020204" pitchFamily="34" charset="0"/>
                        </a:rPr>
                        <a:t>p </a:t>
                      </a:r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= 0.3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8708764"/>
                  </a:ext>
                </a:extLst>
              </a:tr>
            </a:tbl>
          </a:graphicData>
        </a:graphic>
      </p:graphicFrame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049A1C74-58CF-7CA3-8E92-8168575C827B}"/>
              </a:ext>
            </a:extLst>
          </p:cNvPr>
          <p:cNvGraphicFramePr>
            <a:graphicFrameLocks noGrp="1"/>
          </p:cNvGraphicFramePr>
          <p:nvPr/>
        </p:nvGraphicFramePr>
        <p:xfrm>
          <a:off x="6173110" y="5128184"/>
          <a:ext cx="941696" cy="267660"/>
        </p:xfrm>
        <a:graphic>
          <a:graphicData uri="http://schemas.openxmlformats.org/drawingml/2006/table">
            <a:tbl>
              <a:tblPr/>
              <a:tblGrid>
                <a:gridCol w="941696">
                  <a:extLst>
                    <a:ext uri="{9D8B030D-6E8A-4147-A177-3AD203B41FA5}">
                      <a16:colId xmlns:a16="http://schemas.microsoft.com/office/drawing/2014/main" val="1487705710"/>
                    </a:ext>
                  </a:extLst>
                </a:gridCol>
              </a:tblGrid>
              <a:tr h="26766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i="1" u="none" strike="noStrike" dirty="0">
                          <a:effectLst/>
                          <a:latin typeface="Arial" panose="020B0604020202020204" pitchFamily="34" charset="0"/>
                        </a:rPr>
                        <a:t>p </a:t>
                      </a:r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= 0.3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8708764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ECA2344F-C786-F9FA-4396-11DEC27F3C50}"/>
              </a:ext>
            </a:extLst>
          </p:cNvPr>
          <p:cNvSpPr txBox="1"/>
          <p:nvPr/>
        </p:nvSpPr>
        <p:spPr>
          <a:xfrm>
            <a:off x="5950396" y="330747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52503B3-2368-5727-C513-A77BB2A694E0}"/>
              </a:ext>
            </a:extLst>
          </p:cNvPr>
          <p:cNvSpPr txBox="1"/>
          <p:nvPr/>
        </p:nvSpPr>
        <p:spPr>
          <a:xfrm>
            <a:off x="2244664" y="327168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2FCB6CE-3F72-666F-9B5F-CA785D567207}"/>
              </a:ext>
            </a:extLst>
          </p:cNvPr>
          <p:cNvSpPr txBox="1"/>
          <p:nvPr/>
        </p:nvSpPr>
        <p:spPr>
          <a:xfrm>
            <a:off x="2358463" y="3231878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36FC83A-B0C1-3CC1-92E4-537C5BDCC984}"/>
              </a:ext>
            </a:extLst>
          </p:cNvPr>
          <p:cNvSpPr txBox="1"/>
          <p:nvPr/>
        </p:nvSpPr>
        <p:spPr>
          <a:xfrm>
            <a:off x="6055658" y="3157901"/>
            <a:ext cx="3145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D</a:t>
            </a:r>
          </a:p>
        </p:txBody>
      </p:sp>
      <p:sp>
        <p:nvSpPr>
          <p:cNvPr id="18" name="TextBox 3">
            <a:extLst>
              <a:ext uri="{FF2B5EF4-FFF2-40B4-BE49-F238E27FC236}">
                <a16:creationId xmlns:a16="http://schemas.microsoft.com/office/drawing/2014/main" id="{953A5979-4B8D-EDFE-1BDE-7F31D0FC665E}"/>
              </a:ext>
            </a:extLst>
          </p:cNvPr>
          <p:cNvSpPr txBox="1"/>
          <p:nvPr/>
        </p:nvSpPr>
        <p:spPr>
          <a:xfrm>
            <a:off x="2174888" y="5965944"/>
            <a:ext cx="7316602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algn="just">
              <a:spcBef>
                <a:spcPts val="0"/>
              </a:spcBef>
            </a:pP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 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Prognostic impact of CD4 </a:t>
            </a:r>
            <a:r>
              <a:rPr lang="en-US" sz="1400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mmunoscore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groupings</a:t>
            </a: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hown are Kaplan-Meier estimates of overall survival (A,B) and progression free survival (C,D) of OSCC patients stratified by C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4 </a:t>
            </a:r>
            <a:r>
              <a:rPr lang="en-US" sz="1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mmunoscores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 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4177003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10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rnett, Andrean L</dc:creator>
  <cp:lastModifiedBy>Burnett, Andrean L</cp:lastModifiedBy>
  <cp:revision>1</cp:revision>
  <dcterms:created xsi:type="dcterms:W3CDTF">2024-05-01T17:39:37Z</dcterms:created>
  <dcterms:modified xsi:type="dcterms:W3CDTF">2024-05-01T17:40:03Z</dcterms:modified>
</cp:coreProperties>
</file>